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6" r:id="rId4"/>
  </p:sldIdLst>
  <p:sldSz cx="12192000" cy="14417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57" autoAdjust="0"/>
    <p:restoredTop sz="94660"/>
  </p:normalViewPr>
  <p:slideViewPr>
    <p:cSldViewPr snapToGrid="0">
      <p:cViewPr varScale="1">
        <p:scale>
          <a:sx n="42" d="100"/>
          <a:sy n="42" d="100"/>
        </p:scale>
        <p:origin x="247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9560"/>
            <a:ext cx="10363200" cy="501948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72618"/>
            <a:ext cx="9144000" cy="348093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420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31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7608"/>
            <a:ext cx="2628900" cy="12218313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7608"/>
            <a:ext cx="7734300" cy="12218313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640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439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4411"/>
            <a:ext cx="10515600" cy="599735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48499"/>
            <a:ext cx="10515600" cy="315386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428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8039"/>
            <a:ext cx="5181600" cy="914788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8039"/>
            <a:ext cx="5181600" cy="914788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737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7611"/>
            <a:ext cx="10515600" cy="2786751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4334"/>
            <a:ext cx="5157787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6456"/>
            <a:ext cx="5157787" cy="774616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4334"/>
            <a:ext cx="5183188" cy="173212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6456"/>
            <a:ext cx="5183188" cy="774616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6759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006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647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5881"/>
            <a:ext cx="6172200" cy="10245894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187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1178"/>
            <a:ext cx="3932237" cy="3364124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5881"/>
            <a:ext cx="6172200" cy="10245894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5302"/>
            <a:ext cx="3932237" cy="8013158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048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7611"/>
            <a:ext cx="10515600" cy="278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8039"/>
            <a:ext cx="10515600" cy="91478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D2EFF-5381-419E-A03B-07844C979414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63052"/>
            <a:ext cx="41148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63052"/>
            <a:ext cx="2743200" cy="767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C2B5A-C0FF-4E53-A497-E193CEDD3BF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3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6D94342-5D03-9E4D-9680-668CFDC62B3C}"/>
              </a:ext>
            </a:extLst>
          </p:cNvPr>
          <p:cNvSpPr txBox="1"/>
          <p:nvPr/>
        </p:nvSpPr>
        <p:spPr>
          <a:xfrm>
            <a:off x="0" y="0"/>
            <a:ext cx="2760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2a-d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31ACECF6-D551-BB4C-B969-8A78E06340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52" y="498157"/>
            <a:ext cx="7734300" cy="57404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A6FC270B-8062-6848-BD10-A24D80AF836B}"/>
              </a:ext>
            </a:extLst>
          </p:cNvPr>
          <p:cNvSpPr txBox="1"/>
          <p:nvPr/>
        </p:nvSpPr>
        <p:spPr>
          <a:xfrm>
            <a:off x="0" y="498157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a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59F9BD3A-EDEB-F244-93F9-A05BD3B3BF89}"/>
              </a:ext>
            </a:extLst>
          </p:cNvPr>
          <p:cNvSpPr txBox="1"/>
          <p:nvPr/>
        </p:nvSpPr>
        <p:spPr>
          <a:xfrm>
            <a:off x="15422" y="384377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b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1A6AB5C-E527-3E47-9996-130FB3ABF6E1}"/>
              </a:ext>
            </a:extLst>
          </p:cNvPr>
          <p:cNvSpPr txBox="1"/>
          <p:nvPr/>
        </p:nvSpPr>
        <p:spPr>
          <a:xfrm>
            <a:off x="2622296" y="384377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c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211D20E4-3193-9E4A-A025-3913D9FBA37E}"/>
              </a:ext>
            </a:extLst>
          </p:cNvPr>
          <p:cNvSpPr txBox="1"/>
          <p:nvPr/>
        </p:nvSpPr>
        <p:spPr>
          <a:xfrm>
            <a:off x="5132918" y="384377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d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3566893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6D94342-5D03-9E4D-9680-668CFDC62B3C}"/>
              </a:ext>
            </a:extLst>
          </p:cNvPr>
          <p:cNvSpPr txBox="1"/>
          <p:nvPr/>
        </p:nvSpPr>
        <p:spPr>
          <a:xfrm>
            <a:off x="4518" y="0"/>
            <a:ext cx="2760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2e-h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B6A0CAB5-BF3E-2A44-89BB-39660862CB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354" y="436642"/>
            <a:ext cx="7672137" cy="57277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11114FED-DE9B-2340-9E8E-E18C8ED08AA9}"/>
              </a:ext>
            </a:extLst>
          </p:cNvPr>
          <p:cNvSpPr txBox="1"/>
          <p:nvPr/>
        </p:nvSpPr>
        <p:spPr>
          <a:xfrm>
            <a:off x="79226" y="43029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784F1DD-627F-0043-B95C-3A2C5D4C220C}"/>
              </a:ext>
            </a:extLst>
          </p:cNvPr>
          <p:cNvSpPr txBox="1"/>
          <p:nvPr/>
        </p:nvSpPr>
        <p:spPr>
          <a:xfrm>
            <a:off x="30480" y="3743823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f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767B33B-00D2-D840-B527-98945469AA67}"/>
              </a:ext>
            </a:extLst>
          </p:cNvPr>
          <p:cNvSpPr txBox="1"/>
          <p:nvPr/>
        </p:nvSpPr>
        <p:spPr>
          <a:xfrm>
            <a:off x="2589228" y="3743823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g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99E912AD-125B-8D4A-BDB1-5FD88B4E2614}"/>
              </a:ext>
            </a:extLst>
          </p:cNvPr>
          <p:cNvSpPr txBox="1"/>
          <p:nvPr/>
        </p:nvSpPr>
        <p:spPr>
          <a:xfrm>
            <a:off x="5099850" y="3743823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h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9444629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6D94342-5D03-9E4D-9680-668CFDC62B3C}"/>
              </a:ext>
            </a:extLst>
          </p:cNvPr>
          <p:cNvSpPr txBox="1"/>
          <p:nvPr/>
        </p:nvSpPr>
        <p:spPr>
          <a:xfrm>
            <a:off x="0" y="971"/>
            <a:ext cx="2760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2i-p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5BF56CB0-40F9-174D-920D-FFCC98A65B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91" y="400783"/>
            <a:ext cx="7772400" cy="106299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DEFDBCA8-D0EF-AB4C-97D4-7EFB35791BC5}"/>
              </a:ext>
            </a:extLst>
          </p:cNvPr>
          <p:cNvSpPr txBox="1"/>
          <p:nvPr/>
        </p:nvSpPr>
        <p:spPr>
          <a:xfrm>
            <a:off x="30480" y="400783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i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82AC303-7E4E-D545-BC3F-0ED80432241C}"/>
              </a:ext>
            </a:extLst>
          </p:cNvPr>
          <p:cNvSpPr txBox="1"/>
          <p:nvPr/>
        </p:nvSpPr>
        <p:spPr>
          <a:xfrm>
            <a:off x="32085" y="3447951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j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FEB275FF-0373-EB45-B1E8-FA6C25D71911}"/>
              </a:ext>
            </a:extLst>
          </p:cNvPr>
          <p:cNvSpPr txBox="1"/>
          <p:nvPr/>
        </p:nvSpPr>
        <p:spPr>
          <a:xfrm>
            <a:off x="2622917" y="3447951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k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A616AAEE-1D1B-EF4F-945F-702B986256EB}"/>
              </a:ext>
            </a:extLst>
          </p:cNvPr>
          <p:cNvSpPr txBox="1"/>
          <p:nvPr/>
        </p:nvSpPr>
        <p:spPr>
          <a:xfrm>
            <a:off x="5197707" y="3447951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l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6FF8C00-2DF7-8E4E-AD64-C44F4BC5D147}"/>
              </a:ext>
            </a:extLst>
          </p:cNvPr>
          <p:cNvSpPr txBox="1"/>
          <p:nvPr/>
        </p:nvSpPr>
        <p:spPr>
          <a:xfrm>
            <a:off x="0" y="6054792"/>
            <a:ext cx="635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m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39489683-5AA8-B34E-A0B8-522D0381ABCC}"/>
              </a:ext>
            </a:extLst>
          </p:cNvPr>
          <p:cNvSpPr txBox="1"/>
          <p:nvPr/>
        </p:nvSpPr>
        <p:spPr>
          <a:xfrm>
            <a:off x="2574790" y="6054792"/>
            <a:ext cx="6352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n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1DD4FFC6-8179-6549-A92E-E9405321BF14}"/>
              </a:ext>
            </a:extLst>
          </p:cNvPr>
          <p:cNvSpPr txBox="1"/>
          <p:nvPr/>
        </p:nvSpPr>
        <p:spPr>
          <a:xfrm>
            <a:off x="5213749" y="6054792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o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8D68319-9212-314D-A8A7-7DF1438D52AD}"/>
              </a:ext>
            </a:extLst>
          </p:cNvPr>
          <p:cNvSpPr txBox="1"/>
          <p:nvPr/>
        </p:nvSpPr>
        <p:spPr>
          <a:xfrm>
            <a:off x="29193" y="8607356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/>
              <a:t>(p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2308697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7</Words>
  <Application>Microsoft Macintosh PowerPoint</Application>
  <PresentationFormat>Benutzerdefiniert</PresentationFormat>
  <Paragraphs>19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niversitätsmedizin Götting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lakad, Omar Mohamed Ahmed Mohame</dc:creator>
  <cp:lastModifiedBy>Alexander Fichtner</cp:lastModifiedBy>
  <cp:revision>69</cp:revision>
  <dcterms:created xsi:type="dcterms:W3CDTF">2021-04-22T13:07:55Z</dcterms:created>
  <dcterms:modified xsi:type="dcterms:W3CDTF">2021-11-24T21:23:03Z</dcterms:modified>
</cp:coreProperties>
</file>